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741859-D4BE-4C5C-B3B5-B80F24AD69A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0128FE-13EA-4FAF-80D6-1E317616C0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49908F-4220-4023-A9C2-09692A34E35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730554-F6BD-4720-834A-57E3D119F8F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5A0F92-E3BA-41B1-AD6C-4E2B92E26EA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A757F5-2A39-47ED-AA74-5AE3351C4A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6FBBE0-9247-43C5-B808-13EDFAEBD42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FF7D9C-579F-4696-B78F-76ED15814E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7D0A43-5A05-409D-AB46-3AF2DAAC29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931AC5-6248-42E5-BC01-4F2A222AD9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AB28B1-F5B4-4C25-9F19-E7886B8E5E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B01686-A949-4474-B84A-57E2A5BF99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24FCE94-2BC7-4A69-8933-5C80F71B7983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39640" y="585720"/>
            <a:ext cx="8006040" cy="61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Supplemental Table 1.</a:t>
            </a: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 Genes previously confirmed experimentally to express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specifically in certain tissues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539640" y="1484280"/>
          <a:ext cx="7993080" cy="1584360"/>
        </p:xfrm>
        <a:graphic>
          <a:graphicData uri="http://schemas.openxmlformats.org/drawingml/2006/table">
            <a:tbl>
              <a:tblPr/>
              <a:tblGrid>
                <a:gridCol w="2087640"/>
                <a:gridCol w="1657440"/>
                <a:gridCol w="1942920"/>
                <a:gridCol w="1441440"/>
                <a:gridCol w="863640"/>
              </a:tblGrid>
              <a:tr h="3560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e Nam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essio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eferenc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croarray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robe ID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708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r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M_00104404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SG [1]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S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w14946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0708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eta-glucosidas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M_00104360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dgut [2]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dgu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w08497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708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mAHA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B15864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estis [3]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esti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w14798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708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ekti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M_00104340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estis [4]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esti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w02991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3" name=""/>
          <p:cNvSpPr/>
          <p:nvPr/>
        </p:nvSpPr>
        <p:spPr>
          <a:xfrm>
            <a:off x="395280" y="3286080"/>
            <a:ext cx="8280360" cy="3138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2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Times New Roman"/>
              </a:rPr>
              <a:t>References: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2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[1] Michaille JJ, Couble P, Prudhomme JC, Garel A: </a:t>
            </a:r>
            <a:r>
              <a:rPr b="1" lang="zh-CN" sz="1400" spc="-1" strike="noStrike">
                <a:solidFill>
                  <a:srgbClr val="000000"/>
                </a:solidFill>
                <a:latin typeface="Times New Roman"/>
              </a:rPr>
              <a:t>A single gene produces multiple sericin messenger   RNAs in the silk gland of Bombyx mori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. </a:t>
            </a:r>
            <a:r>
              <a:rPr b="0" i="1" lang="zh-CN" sz="1400" spc="-1" strike="noStrike">
                <a:solidFill>
                  <a:srgbClr val="000000"/>
                </a:solidFill>
                <a:latin typeface="Times New Roman"/>
              </a:rPr>
              <a:t>Biochimie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 1986, 68:1165-1173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2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[2] Byeon GM,Lee KS, Gui ZZ, Kim I, Kang PD, Lee SM,Sohn HD, Jin </a:t>
            </a:r>
            <a:r>
              <a:rPr b="1" lang="zh-CN" sz="1400" spc="-1" strike="noStrike">
                <a:solidFill>
                  <a:srgbClr val="000000"/>
                </a:solidFill>
                <a:latin typeface="Times New Roman"/>
              </a:rPr>
              <a:t>BR:A digestive beta-glucosidase from the silkworm, Bombyx mori: cDNA cloning, expression and enzymatic characterization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. </a:t>
            </a:r>
            <a:r>
              <a:rPr b="0" i="1" lang="zh-CN" sz="1400" spc="-1" strike="noStrike">
                <a:solidFill>
                  <a:srgbClr val="000000"/>
                </a:solidFill>
                <a:latin typeface="Times New Roman"/>
              </a:rPr>
              <a:t>Comp Biochem Physiol B Biochem Mol Biol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 2005 141:418-427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2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[3] Miyagawa Y, Lee JM, Maeda T, Koga K, Kawaguchi Y, Kusakabe </a:t>
            </a:r>
            <a:r>
              <a:rPr b="1" lang="zh-CN" sz="1400" spc="-1" strike="noStrike">
                <a:solidFill>
                  <a:srgbClr val="000000"/>
                </a:solidFill>
                <a:latin typeface="Times New Roman"/>
              </a:rPr>
              <a:t>T:Differential expression of a Bombyx mori AHA1 homologue during spermatogenesis.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Times New Roman"/>
              </a:rPr>
              <a:t>Insect Mol Biol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 2005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14(3):245-253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2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[4] Ota A, Kusakabe T, Sugimoto Y, Takahashi M, Nakajima Y, Kawaguchi Y, Koga K: </a:t>
            </a:r>
            <a:r>
              <a:rPr b="1" lang="zh-CN" sz="1400" spc="-1" strike="noStrike">
                <a:solidFill>
                  <a:srgbClr val="000000"/>
                </a:solidFill>
                <a:latin typeface="Times New Roman"/>
              </a:rPr>
              <a:t>Cloning and characterization of testis-specific tektin in Bombyx mori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. </a:t>
            </a:r>
            <a:r>
              <a:rPr b="0" i="1" lang="zh-CN" sz="1400" spc="-1" strike="noStrike">
                <a:solidFill>
                  <a:srgbClr val="000000"/>
                </a:solidFill>
                <a:latin typeface="Times New Roman"/>
              </a:rPr>
              <a:t>Comp Biochem Physiol B Biochem Mol Biol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 2002, 133: 371-382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2-17T17:07:59Z</dcterms:created>
  <dc:creator>番茄花园</dc:creator>
  <dc:description/>
  <dc:language>en-US</dc:language>
  <cp:lastModifiedBy>chengdj</cp:lastModifiedBy>
  <dcterms:modified xsi:type="dcterms:W3CDTF">2007-06-12T19:02:43Z</dcterms:modified>
  <cp:revision>17</cp:revision>
  <dc:subject/>
  <dc:title>幻灯片 1</dc:title>
</cp:coreProperties>
</file>